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7" r:id="rId2"/>
  </p:sldIdLst>
  <p:sldSz cx="9144000" cy="6858000" type="screen4x3"/>
  <p:notesSz cx="6802438" cy="99345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0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66"/>
    <a:srgbClr val="FF9933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 horzBarState="maximized">
    <p:restoredLeft sz="9543" autoAdjust="0"/>
    <p:restoredTop sz="94286" autoAdjust="0"/>
  </p:normalViewPr>
  <p:slideViewPr>
    <p:cSldViewPr snapToGrid="0" showGuides="1">
      <p:cViewPr varScale="1">
        <p:scale>
          <a:sx n="74" d="100"/>
          <a:sy n="74" d="100"/>
        </p:scale>
        <p:origin x="1710" y="72"/>
      </p:cViewPr>
      <p:guideLst>
        <p:guide orient="horz" pos="2183"/>
        <p:guide pos="306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88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AC5E88-D579-42A9-8D53-63CC681BFAF5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88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507A4F-02B6-459F-BFB4-1C499E2E1F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551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9442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3948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4925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158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7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895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726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493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555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94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0574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F58985-6C73-43F6-AD96-6CEC446AEE9A}" type="datetimeFigureOut">
              <a:rPr kumimoji="1" lang="ja-JP" altLang="en-US" smtClean="0"/>
              <a:t>2021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BD5C0-3BAD-4F9F-A240-EB504D64E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7326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321335"/>
              </p:ext>
            </p:extLst>
          </p:nvPr>
        </p:nvGraphicFramePr>
        <p:xfrm>
          <a:off x="617839" y="907401"/>
          <a:ext cx="7970018" cy="4907280"/>
        </p:xfrm>
        <a:graphic>
          <a:graphicData uri="http://schemas.openxmlformats.org/drawingml/2006/table">
            <a:tbl>
              <a:tblPr firstRow="1" firstCol="1" bandRow="1"/>
              <a:tblGrid>
                <a:gridCol w="363240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15323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18437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47955">
                <a:tc>
                  <a:txBody>
                    <a:bodyPr/>
                    <a:lstStyle/>
                    <a:p>
                      <a:pPr indent="334645" algn="just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leep architecture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Metabolic parameters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otal HD patients (n=88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          TG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      Non-HDL-C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Total sleep time (min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192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73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320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02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REM sleep latency (min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292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06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287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07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0453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leep efficiency (%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19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63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32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01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Wake after sleep onset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 (WASO) (min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216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043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08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444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apid eye movement</a:t>
                      </a: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 (REM) 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(min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131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223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24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019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tage 1 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‐ 0.046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672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025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819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tage 2 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(min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198,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064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380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003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low wave sleep (SWS)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 (min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030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778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24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022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pnea hypopnea index (AHI) (no./h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- 0.16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130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168, </a:t>
                      </a:r>
                      <a:r>
                        <a:rPr lang="en-US" sz="1400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121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pPr marL="179705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entral AHI (no./h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- 0.14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184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010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925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2DM HD patients (n= 36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        FPG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       HbA1c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Total sleep time 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211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216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20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220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REM sleep latency 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‐ 0.354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34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382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21*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leep efficiency (%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148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388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31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057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Wake after sleep onset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 (WASO) 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  0.174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311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076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657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apid eye movement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 (REM) 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‐ 0.11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513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08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604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tage 1 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307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069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- 0.12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452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tage 2 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111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519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194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256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 fontAlgn="base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Slow wave sleep (SWS)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ゴシック" panose="020B0609070205080204" pitchFamily="49" charset="-128"/>
                          <a:cs typeface="Times New Roman" panose="02020603050405020304" pitchFamily="18" charset="0"/>
                        </a:rPr>
                        <a:t> (min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091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597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  0.184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283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pnea hypopnea index (AHI) (no./h)</a:t>
                      </a:r>
                      <a:endParaRPr lang="ja-JP" sz="14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- 0.07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672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019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911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marL="179705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entral AHI (no./h)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= - 0.247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= 0.205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= - 0.053, </a:t>
                      </a:r>
                      <a:r>
                        <a:rPr lang="en-US" sz="1400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= 0.760</a:t>
                      </a:r>
                      <a:endParaRPr lang="ja-JP" sz="1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540000" y="180000"/>
            <a:ext cx="81179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1. Univariate</a:t>
            </a:r>
            <a:r>
              <a:rPr lang="en-US" altLang="ja-JP" sz="1400" strike="sngStrik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of various parameters of sleep architecture with lipid profiles and glycemic markers in HD patients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6117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04</TotalTime>
  <Words>494</Words>
  <Application>Microsoft Office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ＭＳ ゴシック</vt:lpstr>
      <vt:lpstr>ＭＳ 明朝</vt:lpstr>
      <vt:lpstr>ＭＳ Ｐ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アカウント</dc:creator>
  <cp:lastModifiedBy>Saranya G.</cp:lastModifiedBy>
  <cp:revision>793</cp:revision>
  <cp:lastPrinted>2020-02-27T03:18:59Z</cp:lastPrinted>
  <dcterms:created xsi:type="dcterms:W3CDTF">2016-12-11T15:10:44Z</dcterms:created>
  <dcterms:modified xsi:type="dcterms:W3CDTF">2021-03-22T09:05:40Z</dcterms:modified>
</cp:coreProperties>
</file>